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4F0B0-E972-40B2-8EA6-013E3534D6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CFDA2-669D-401F-9E58-625FF83943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5DEB20-6386-4595-A7CE-BF49B0C3BD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C46F9-7C3E-446F-9A8D-593D382093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76B60-0642-46ED-B4ED-83EE8C620B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E020B-0891-42EC-8EBE-78997A920C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8C7AF-67E7-44FE-BA76-079FC6D5B9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425EB-1056-468C-8143-CA35810886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518CE-98B9-429F-A13E-E22753B5DA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DBFE2-3A02-4D92-9A5F-BD5D78A7E3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E80D9-B8E8-45BB-8A6E-A4DD93CEF0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573D7-9191-4AAF-B120-E79D76ADA5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9EE9FC-86FC-4C40-91CD-7342986C918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G:\F\B_ZhejiangUniversity\稗草叶绿体\v7\提交\combined_cp_divergence\single_copy_gene_divergence_time2.tif"/>
          <p:cNvPicPr/>
          <p:nvPr/>
        </p:nvPicPr>
        <p:blipFill>
          <a:blip r:embed="rId1"/>
          <a:stretch/>
        </p:blipFill>
        <p:spPr>
          <a:xfrm>
            <a:off x="380880" y="2057400"/>
            <a:ext cx="5996160" cy="3733920"/>
          </a:xfrm>
          <a:prstGeom prst="rect">
            <a:avLst/>
          </a:prstGeom>
          <a:ln w="0">
            <a:noFill/>
          </a:ln>
        </p:spPr>
      </p:pic>
      <p:sp>
        <p:nvSpPr>
          <p:cNvPr id="42" name="TextBox 6"/>
          <p:cNvSpPr/>
          <p:nvPr/>
        </p:nvSpPr>
        <p:spPr>
          <a:xfrm>
            <a:off x="0" y="7696080"/>
            <a:ext cx="6858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Figure S6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vergence time of the genus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chinochlo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Divergence time was estimated using BEAST based on coding sequences of single copy genes shared among the six species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oryzico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crus-gall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virgatu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bicolo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. may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. Sativ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The numbers showed at nodes indicate divergence tim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chuyuye</dc:creator>
  <dc:description/>
  <dc:language>en-US</dc:language>
  <cp:lastModifiedBy>user</cp:lastModifiedBy>
  <dcterms:modified xsi:type="dcterms:W3CDTF">2014-11-01T04:19:06Z</dcterms:modified>
  <cp:revision>52</cp:revision>
  <dc:subject/>
  <dc:title>Slide 1</dc:title>
</cp:coreProperties>
</file>